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8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23" autoAdjust="0"/>
    <p:restoredTop sz="94660"/>
  </p:normalViewPr>
  <p:slideViewPr>
    <p:cSldViewPr snapToGrid="0" showGuides="1">
      <p:cViewPr varScale="1">
        <p:scale>
          <a:sx n="120" d="100"/>
          <a:sy n="120" d="100"/>
        </p:scale>
        <p:origin x="464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31160E-8367-4A37-A6F7-8EC08DBCFE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1FBC3C4-484C-4EFF-A8C8-E0CD439592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60D5B4-BA7D-4E6A-87A9-25FF055F3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25C2D1-53BC-4B32-A893-F5C1C458E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9D57EA-6B14-4156-AD3E-1AF3C520D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23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66E584-6307-44AA-8F58-6B38348BBF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0B6276A-2E4E-49A8-A97E-AEFC9F2963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9185A7-E883-4F9D-B4B0-610EB3A64B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936D5C-C7E5-44A5-86ED-3416CED26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144551-630D-4A8F-9688-5B2053808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124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66424B7-B88E-454B-BA30-01F61BCD8C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99F2367-ABAE-4E60-88A2-DE83A79131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E12518-F871-4A8D-B231-A29E2F63B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CC765C-F919-4C9E-8C09-298771856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40AD8E-5C52-436E-9DB9-0D4F31EB7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524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663C8D-D354-45D3-9B3E-34F138EA4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DFCB51D-2BB7-48AC-AAFC-0F013F5BC6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61B57C-3CCB-4B9E-9E1B-4E4028F79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155CBC-06DC-4DF2-9933-FFE5A5087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FE01E1-732D-494F-857A-624500830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57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613A5A-4FAF-4104-B644-449D84119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82AFF32-3EDF-48EB-845C-B90DECCFD8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2A1DA0-635E-4B77-977D-6BAAE642D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B9145C-F6D2-43FE-835B-264F7FA09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7A63E4-1EFA-4196-A344-6C8C674D9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620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2C1D46-02B8-4534-BD27-71BEC53EE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8E54EF7-E707-41D0-9D2B-2E52C43A44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3289CC2-F580-4433-89B2-6F7AA4162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EE69052-E96A-4E3B-88C3-C6782BB5B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825755-0F37-44E0-9458-9CA31F2BB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16E8B-DB8C-442C-89BB-59845C115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331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9941EF-AEC0-4176-BEB7-3365E73EED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DD4F68-0E42-42F9-B72B-6D1D6CADB3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23E61A-F4F7-49CD-A218-688DD27B93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B9FB287-824B-455B-BB1F-5C6C56D0CE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3A80CF6-6954-4ADE-AD3C-CC92500413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183D401-31E7-431E-8D27-7C0826CC6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44C5537-90C9-4F7D-BE91-6484825F6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8738AB5-EE78-4A9B-AA2F-B879C81F9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214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100B61-5A07-4482-894A-BF60DF6B95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08BF2F2-C7D8-4489-BEEC-1B96100A8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FDC363-8D87-43E0-B31E-87401615D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B804105-B0C8-423F-AC8B-312880181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10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79BF1C3-625F-4F0A-A808-4FADC5637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95A4C16-E438-4027-A9A7-A3DB79205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4364A80-9BE5-4C07-A5DB-7A0FF1926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239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36EE24-87FC-4D52-A70A-1006485F0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D1683E-225A-4DDF-8DB0-3269E8B878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AF3BFF-CF9A-46EA-9CD7-22DC77AA8F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066B50-F6C3-4DA7-BD47-19F150633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BC10AB6-F8CD-4F73-B264-5F49CC2D9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70D8D9-DB9E-4392-A4C3-A9C6995F0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003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5774A0-D021-405A-837C-942927C3F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6D024CE-DC85-4170-AFC5-E7BA18A11A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108690-689F-4F88-BA74-9E453C013D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6027BA-F258-4977-9EC6-A1F0D9F97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4FA4239-C3BC-4663-828C-D92FE8F8C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97E5728-79AD-49B8-972C-29E364675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6142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2E43E01-C964-4C12-8FF0-C1F47EAC3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70C7FB6-0589-4398-9396-D82E2C54FB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818C64-F8A5-48E5-9A53-CDBC7F02F2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329E7-847C-439F-BA24-934E6BF4BFF0}" type="datetimeFigureOut">
              <a:rPr kumimoji="1" lang="ja-JP" altLang="en-US" smtClean="0"/>
              <a:t>2025/12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921E9A-4FC6-4979-BDD5-B9ABFBCC16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2A61EA7-04C1-463F-B6A2-BECC4860BB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A5500-AD51-4DB7-995F-967170A23A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32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E39BB6D-07C4-4C15-B917-097C23FEF6DD}"/>
              </a:ext>
            </a:extLst>
          </p:cNvPr>
          <p:cNvSpPr txBox="1"/>
          <p:nvPr/>
        </p:nvSpPr>
        <p:spPr>
          <a:xfrm>
            <a:off x="103601" y="200646"/>
            <a:ext cx="272751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Cambria" panose="02040503050406030204" pitchFamily="18" charset="0"/>
                <a:ea typeface="メイリオ"/>
                <a:cs typeface="Times New Roman" panose="02020603050405020304" pitchFamily="18" charset="0"/>
              </a:rPr>
              <a:t> Fig</a:t>
            </a:r>
            <a:r>
              <a:rPr lang="en-US" altLang="ja-JP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ure </a:t>
            </a:r>
            <a:r>
              <a:rPr lang="ja-JP" altLang="en-US" dirty="0">
                <a:latin typeface="Cambria" panose="02040503050406030204" pitchFamily="18" charset="0"/>
                <a:ea typeface="メイリオ"/>
                <a:cs typeface="Times New Roman" panose="02020603050405020304" pitchFamily="18" charset="0"/>
              </a:rPr>
              <a:t>1</a:t>
            </a:r>
            <a:endParaRPr kumimoji="1" lang="en-US" altLang="ja-JP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C64CB37-0359-427A-B5AE-4B8890260622}"/>
              </a:ext>
            </a:extLst>
          </p:cNvPr>
          <p:cNvSpPr txBox="1"/>
          <p:nvPr/>
        </p:nvSpPr>
        <p:spPr>
          <a:xfrm>
            <a:off x="1145754" y="855959"/>
            <a:ext cx="5206821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with a definitive diagnosis of acute upper respiratory infection in the outpatient between 2019 and 2021</a:t>
            </a:r>
          </a:p>
          <a:p>
            <a:r>
              <a:rPr kumimoji="1"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967,546</a:t>
            </a:r>
            <a:endParaRPr kumimoji="1" lang="ja-JP" altLang="en-US" sz="1100" dirty="0">
              <a:latin typeface="Cambria" panose="020405030504060302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C861B83-EDAA-4DE9-95ED-F9309C7AFF94}"/>
              </a:ext>
            </a:extLst>
          </p:cNvPr>
          <p:cNvSpPr txBox="1"/>
          <p:nvPr/>
        </p:nvSpPr>
        <p:spPr>
          <a:xfrm>
            <a:off x="1145754" y="1997221"/>
            <a:ext cx="4140000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who claimed AS implementation fee for pediatric patient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46,943</a:t>
            </a:r>
            <a:endParaRPr kumimoji="1" lang="ja-JP" altLang="en-US" sz="1100" dirty="0">
              <a:latin typeface="Cambria" panose="020405030504060302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1CC6B07-6193-4B61-87AB-8685D69B0655}"/>
              </a:ext>
            </a:extLst>
          </p:cNvPr>
          <p:cNvSpPr txBox="1"/>
          <p:nvPr/>
        </p:nvSpPr>
        <p:spPr>
          <a:xfrm>
            <a:off x="6818811" y="1480997"/>
            <a:ext cx="4464000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who did not claim AS implementation fee for pediatric patient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920,603</a:t>
            </a: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8A70B364-1E61-44B1-90D3-7F35CB3EA510}"/>
              </a:ext>
            </a:extLst>
          </p:cNvPr>
          <p:cNvCxnSpPr>
            <a:cxnSpLocks/>
          </p:cNvCxnSpPr>
          <p:nvPr/>
        </p:nvCxnSpPr>
        <p:spPr>
          <a:xfrm>
            <a:off x="1656615" y="1693328"/>
            <a:ext cx="5162196" cy="80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408AB753-6CFD-4D3F-8973-F8CD8BB00804}"/>
              </a:ext>
            </a:extLst>
          </p:cNvPr>
          <p:cNvCxnSpPr>
            <a:cxnSpLocks/>
          </p:cNvCxnSpPr>
          <p:nvPr/>
        </p:nvCxnSpPr>
        <p:spPr>
          <a:xfrm flipH="1">
            <a:off x="1651710" y="1458865"/>
            <a:ext cx="1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001B999-57FE-4C27-9F6A-70C7FD706A00}"/>
              </a:ext>
            </a:extLst>
          </p:cNvPr>
          <p:cNvSpPr txBox="1"/>
          <p:nvPr/>
        </p:nvSpPr>
        <p:spPr>
          <a:xfrm>
            <a:off x="1145754" y="2971106"/>
            <a:ext cx="100526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ge &lt;6 year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45,470</a:t>
            </a:r>
            <a:endParaRPr kumimoji="1" lang="ja-JP" altLang="en-US" sz="1100" dirty="0">
              <a:latin typeface="Cambria" panose="020405030504060302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2E1F607-7C0D-4875-A620-E16EB7344AC4}"/>
              </a:ext>
            </a:extLst>
          </p:cNvPr>
          <p:cNvSpPr txBox="1"/>
          <p:nvPr/>
        </p:nvSpPr>
        <p:spPr>
          <a:xfrm>
            <a:off x="6818810" y="3201295"/>
            <a:ext cx="3240000" cy="9387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Missing data</a:t>
            </a:r>
            <a:r>
              <a:rPr lang="ja-JP" altLang="en-US" sz="1100" dirty="0">
                <a:latin typeface="Cambria" panose="020405030504060302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endParaRPr lang="en-US" altLang="ja-JP" sz="1100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marL="182563" indent="-84138">
              <a:buFont typeface="Times New Roman" panose="02020603050405020304" pitchFamily="18" charset="0"/>
              <a:buChar char="‣"/>
            </a:pPr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umber of beds unknown </a:t>
            </a:r>
            <a:b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</a:br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726</a:t>
            </a:r>
          </a:p>
          <a:p>
            <a:pPr marL="182563" indent="-84138">
              <a:buFont typeface="Times New Roman" panose="02020603050405020304" pitchFamily="18" charset="0"/>
              <a:buChar char="‣"/>
            </a:pPr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S implementation fee claimed date is unknown</a:t>
            </a:r>
            <a:r>
              <a:rPr lang="ja-JP" altLang="en-US" sz="1100" dirty="0">
                <a:latin typeface="Cambria" panose="020405030504060302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b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</a:br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1,196</a:t>
            </a: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06B58ECC-E301-4BCB-8136-45C65C5A2364}"/>
              </a:ext>
            </a:extLst>
          </p:cNvPr>
          <p:cNvCxnSpPr>
            <a:cxnSpLocks/>
          </p:cNvCxnSpPr>
          <p:nvPr/>
        </p:nvCxnSpPr>
        <p:spPr>
          <a:xfrm>
            <a:off x="1656615" y="3675271"/>
            <a:ext cx="516461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387D306-DF3B-4FC7-B6D5-EF02101E7854}"/>
              </a:ext>
            </a:extLst>
          </p:cNvPr>
          <p:cNvSpPr txBox="1"/>
          <p:nvPr/>
        </p:nvSpPr>
        <p:spPr>
          <a:xfrm>
            <a:off x="6818810" y="2471986"/>
            <a:ext cx="105373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ge ≥6 year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1,473</a:t>
            </a:r>
          </a:p>
        </p:txBody>
      </p: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7B0FD185-1781-409C-A418-3197E0087574}"/>
              </a:ext>
            </a:extLst>
          </p:cNvPr>
          <p:cNvCxnSpPr>
            <a:cxnSpLocks/>
          </p:cNvCxnSpPr>
          <p:nvPr/>
        </p:nvCxnSpPr>
        <p:spPr>
          <a:xfrm>
            <a:off x="1656615" y="2679666"/>
            <a:ext cx="5162196" cy="155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D9570EA-F85A-4FB6-AF34-76D0065C5346}"/>
              </a:ext>
            </a:extLst>
          </p:cNvPr>
          <p:cNvSpPr txBox="1"/>
          <p:nvPr/>
        </p:nvSpPr>
        <p:spPr>
          <a:xfrm>
            <a:off x="1145753" y="5080295"/>
            <a:ext cx="2268000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not prescribed antibiotic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43,404</a:t>
            </a:r>
            <a:endParaRPr kumimoji="1" lang="ja-JP" altLang="en-US" sz="1100" dirty="0">
              <a:latin typeface="Cambria" panose="020405030504060302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F025B29-69E3-406B-B0C2-B91754820A5B}"/>
              </a:ext>
            </a:extLst>
          </p:cNvPr>
          <p:cNvSpPr txBox="1"/>
          <p:nvPr/>
        </p:nvSpPr>
        <p:spPr>
          <a:xfrm>
            <a:off x="4638914" y="5080295"/>
            <a:ext cx="2016000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prescribed antibiotics</a:t>
            </a: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</a:t>
            </a:r>
            <a:r>
              <a:rPr lang="ja-JP" altLang="en-US" sz="1100" dirty="0">
                <a:latin typeface="Cambria" panose="020405030504060302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144</a:t>
            </a:r>
          </a:p>
        </p:txBody>
      </p:sp>
      <p:cxnSp>
        <p:nvCxnSpPr>
          <p:cNvPr id="6" name="コネクタ: カギ線 5">
            <a:extLst>
              <a:ext uri="{FF2B5EF4-FFF2-40B4-BE49-F238E27FC236}">
                <a16:creationId xmlns:a16="http://schemas.microsoft.com/office/drawing/2014/main" id="{6E37E199-4B91-4686-AA62-040854A2B390}"/>
              </a:ext>
            </a:extLst>
          </p:cNvPr>
          <p:cNvCxnSpPr>
            <a:cxnSpLocks/>
          </p:cNvCxnSpPr>
          <p:nvPr/>
        </p:nvCxnSpPr>
        <p:spPr>
          <a:xfrm>
            <a:off x="1652495" y="4735664"/>
            <a:ext cx="3944578" cy="345765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0143344-A6DC-4190-88CC-89FD3DF1949F}"/>
              </a:ext>
            </a:extLst>
          </p:cNvPr>
          <p:cNvSpPr txBox="1"/>
          <p:nvPr/>
        </p:nvSpPr>
        <p:spPr>
          <a:xfrm>
            <a:off x="1145754" y="3942701"/>
            <a:ext cx="4932000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Patients aged &lt;6 years for whom the AS implementation fee was claimed on the date of first definitive diagnosis of acute URI</a:t>
            </a:r>
            <a:r>
              <a:rPr lang="ja-JP" altLang="en-US" sz="1100" baseline="300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*</a:t>
            </a:r>
            <a:endParaRPr lang="en-US" altLang="ja-JP" sz="1100" baseline="30000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n = 43,548</a:t>
            </a:r>
            <a:endParaRPr kumimoji="1" lang="ja-JP" altLang="en-US" sz="1100" dirty="0">
              <a:latin typeface="Cambria" panose="020405030504060302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158784BF-F197-4FA7-90F9-16E84519886F}"/>
              </a:ext>
            </a:extLst>
          </p:cNvPr>
          <p:cNvCxnSpPr>
            <a:cxnSpLocks/>
          </p:cNvCxnSpPr>
          <p:nvPr/>
        </p:nvCxnSpPr>
        <p:spPr>
          <a:xfrm flipH="1">
            <a:off x="1651710" y="3405271"/>
            <a:ext cx="1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F41E3B96-2F41-40F3-ADD6-945C516EB216}"/>
              </a:ext>
            </a:extLst>
          </p:cNvPr>
          <p:cNvCxnSpPr>
            <a:cxnSpLocks/>
          </p:cNvCxnSpPr>
          <p:nvPr/>
        </p:nvCxnSpPr>
        <p:spPr>
          <a:xfrm flipH="1">
            <a:off x="1651710" y="4549429"/>
            <a:ext cx="1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E3D3E1E6-AA29-4000-AA29-3437B175293F}"/>
              </a:ext>
            </a:extLst>
          </p:cNvPr>
          <p:cNvCxnSpPr>
            <a:cxnSpLocks/>
          </p:cNvCxnSpPr>
          <p:nvPr/>
        </p:nvCxnSpPr>
        <p:spPr>
          <a:xfrm flipH="1">
            <a:off x="1651710" y="2433293"/>
            <a:ext cx="1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7360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2</TotalTime>
  <Words>124</Words>
  <Application>Microsoft Macintosh PowerPoint</Application>
  <PresentationFormat>ワイド画面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mbria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香菜子</dc:creator>
  <cp:lastModifiedBy>村木優一</cp:lastModifiedBy>
  <cp:revision>50</cp:revision>
  <cp:lastPrinted>2025-10-21T01:51:05Z</cp:lastPrinted>
  <dcterms:created xsi:type="dcterms:W3CDTF">2024-02-15T09:12:44Z</dcterms:created>
  <dcterms:modified xsi:type="dcterms:W3CDTF">2025-12-08T00:39:44Z</dcterms:modified>
</cp:coreProperties>
</file>